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2052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nrique María Mateu de Antonio" userId="678ddb83-0020-4a06-85d2-928a222534ef" providerId="ADAL" clId="{6E73245A-83E4-4FDE-AAEC-06AB404E6CBA}"/>
    <pc:docChg chg="modSld">
      <pc:chgData name="Enrique María Mateu de Antonio" userId="678ddb83-0020-4a06-85d2-928a222534ef" providerId="ADAL" clId="{6E73245A-83E4-4FDE-AAEC-06AB404E6CBA}" dt="2025-04-22T12:46:06.157" v="1" actId="404"/>
      <pc:docMkLst>
        <pc:docMk/>
      </pc:docMkLst>
      <pc:sldChg chg="modSp mod">
        <pc:chgData name="Enrique María Mateu de Antonio" userId="678ddb83-0020-4a06-85d2-928a222534ef" providerId="ADAL" clId="{6E73245A-83E4-4FDE-AAEC-06AB404E6CBA}" dt="2025-04-22T12:46:06.157" v="1" actId="404"/>
        <pc:sldMkLst>
          <pc:docMk/>
          <pc:sldMk cId="3519374176" sldId="256"/>
        </pc:sldMkLst>
        <pc:spChg chg="mod">
          <ac:chgData name="Enrique María Mateu de Antonio" userId="678ddb83-0020-4a06-85d2-928a222534ef" providerId="ADAL" clId="{6E73245A-83E4-4FDE-AAEC-06AB404E6CBA}" dt="2025-04-22T12:46:06.157" v="1" actId="404"/>
          <ac:spMkLst>
            <pc:docMk/>
            <pc:sldMk cId="3519374176" sldId="256"/>
            <ac:spMk id="3" creationId="{490E8994-D246-F505-CC58-0CD34D1F069D}"/>
          </ac:spMkLst>
        </pc:spChg>
      </pc:sldChg>
    </pc:docChg>
  </pc:docChgLst>
  <pc:docChgLst>
    <pc:chgData name="Enrique María Mateu de Antonio" userId="678ddb83-0020-4a06-85d2-928a222534ef" providerId="ADAL" clId="{FCF1AC83-0ACF-4B19-9D96-8918A6E95491}"/>
    <pc:docChg chg="modSld">
      <pc:chgData name="Enrique María Mateu de Antonio" userId="678ddb83-0020-4a06-85d2-928a222534ef" providerId="ADAL" clId="{FCF1AC83-0ACF-4B19-9D96-8918A6E95491}" dt="2025-04-07T13:43:58.708" v="7" actId="113"/>
      <pc:docMkLst>
        <pc:docMk/>
      </pc:docMkLst>
      <pc:sldChg chg="addSp modSp mod">
        <pc:chgData name="Enrique María Mateu de Antonio" userId="678ddb83-0020-4a06-85d2-928a222534ef" providerId="ADAL" clId="{FCF1AC83-0ACF-4B19-9D96-8918A6E95491}" dt="2025-04-07T13:43:58.708" v="7" actId="113"/>
        <pc:sldMkLst>
          <pc:docMk/>
          <pc:sldMk cId="3519374176" sldId="256"/>
        </pc:sldMkLst>
        <pc:spChg chg="add mod">
          <ac:chgData name="Enrique María Mateu de Antonio" userId="678ddb83-0020-4a06-85d2-928a222534ef" providerId="ADAL" clId="{FCF1AC83-0ACF-4B19-9D96-8918A6E95491}" dt="2025-04-07T13:43:58.708" v="7" actId="113"/>
          <ac:spMkLst>
            <pc:docMk/>
            <pc:sldMk cId="3519374176" sldId="256"/>
            <ac:spMk id="3" creationId="{490E8994-D246-F505-CC58-0CD34D1F069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a-ES"/>
              <a:t>Feu clic aquí per editar l'estil de subtítols del patró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0555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9220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8477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5371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865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44525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3580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2043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03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7216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a-ES"/>
              <a:t>Feu clic a la icona per afegir una imat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8232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DC3515-3A55-4D04-93D7-413C17AD30A8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E9DF42-34CA-45FB-8090-FFDD3F2BD69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4077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e 5">
            <a:extLst>
              <a:ext uri="{FF2B5EF4-FFF2-40B4-BE49-F238E27FC236}">
                <a16:creationId xmlns:a16="http://schemas.microsoft.com/office/drawing/2014/main" id="{ACBB4A38-00CB-7DF3-436F-F37D1C27C1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7621855"/>
              </p:ext>
            </p:extLst>
          </p:nvPr>
        </p:nvGraphicFramePr>
        <p:xfrm>
          <a:off x="11689" y="1842448"/>
          <a:ext cx="6800862" cy="62506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7979527" imgH="7333457" progId="Prism10.Document">
                  <p:embed/>
                </p:oleObj>
              </mc:Choice>
              <mc:Fallback>
                <p:oleObj name="Prism 10" r:id="rId2" imgW="7979527" imgH="7333457" progId="Prism10.Document">
                  <p:embed/>
                  <p:pic>
                    <p:nvPicPr>
                      <p:cNvPr id="6" name="Objecte 5">
                        <a:extLst>
                          <a:ext uri="{FF2B5EF4-FFF2-40B4-BE49-F238E27FC236}">
                            <a16:creationId xmlns:a16="http://schemas.microsoft.com/office/drawing/2014/main" id="{ACBB4A38-00CB-7DF3-436F-F37D1C27C1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689" y="1842448"/>
                        <a:ext cx="6800862" cy="62506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QuadreDeText 2">
            <a:extLst>
              <a:ext uri="{FF2B5EF4-FFF2-40B4-BE49-F238E27FC236}">
                <a16:creationId xmlns:a16="http://schemas.microsoft.com/office/drawing/2014/main" id="{490E8994-D246-F505-CC58-0CD34D1F069D}"/>
              </a:ext>
            </a:extLst>
          </p:cNvPr>
          <p:cNvSpPr txBox="1"/>
          <p:nvPr/>
        </p:nvSpPr>
        <p:spPr>
          <a:xfrm>
            <a:off x="219458" y="293765"/>
            <a:ext cx="663854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3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era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inica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ore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e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c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serv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V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non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non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V/Ch = no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or =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rcil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R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 = Innovac 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 = p&lt;0.05; ** = p&lt;0.01; *** = p&lt;0.001, **** =p&lt;0.0001.</a:t>
            </a:r>
          </a:p>
        </p:txBody>
      </p:sp>
    </p:spTree>
    <p:extLst>
      <p:ext uri="{BB962C8B-B14F-4D97-AF65-F5344CB8AC3E}">
        <p14:creationId xmlns:p14="http://schemas.microsoft.com/office/powerpoint/2010/main" val="35193741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Tema de l'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l'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l'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7</TotalTime>
  <Words>72</Words>
  <Application>Microsoft Office PowerPoint</Application>
  <PresentationFormat>Paper A4 (210 x 297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Servidors OLE incrustats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Tema de l'Office</vt:lpstr>
      <vt:lpstr>Prism 10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nrique María Mateu de Antonio</dc:creator>
  <cp:lastModifiedBy>Enrique María Mateu de Antonio</cp:lastModifiedBy>
  <cp:revision>1</cp:revision>
  <dcterms:created xsi:type="dcterms:W3CDTF">2025-02-06T12:16:02Z</dcterms:created>
  <dcterms:modified xsi:type="dcterms:W3CDTF">2025-04-22T12:46:09Z</dcterms:modified>
</cp:coreProperties>
</file>